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7" r:id="rId3"/>
    <p:sldId id="259" r:id="rId4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3042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huc-Nghi\Desktop\DD%20data\p53DD%20flow%20cytometry%20data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Thuc-Nghi\Downloads\OCIM1%20flow%20data%20Sep%202016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677236371383677"/>
          <c:y val="0.25435272156538163"/>
          <c:w val="0.75518930483182278"/>
          <c:h val="0.582572824189539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62</c:f>
              <c:strCache>
                <c:ptCount val="1"/>
                <c:pt idx="0">
                  <c:v>DA3/EPOR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B$79:$B$82</c:f>
                <c:numCache>
                  <c:formatCode>General</c:formatCode>
                  <c:ptCount val="4"/>
                  <c:pt idx="0">
                    <c:v>1.3914181414817202</c:v>
                  </c:pt>
                  <c:pt idx="1">
                    <c:v>7.1985399754240298</c:v>
                  </c:pt>
                  <c:pt idx="2">
                    <c:v>0.11348029687032812</c:v>
                  </c:pt>
                  <c:pt idx="3">
                    <c:v>0.18520259177452134</c:v>
                  </c:pt>
                </c:numCache>
              </c:numRef>
            </c:plus>
            <c:minus>
              <c:numRef>
                <c:f>Sheet1!$B$79:$B$82</c:f>
                <c:numCache>
                  <c:formatCode>General</c:formatCode>
                  <c:ptCount val="4"/>
                  <c:pt idx="0">
                    <c:v>1.3914181414817202</c:v>
                  </c:pt>
                  <c:pt idx="1">
                    <c:v>7.1985399754240298</c:v>
                  </c:pt>
                  <c:pt idx="2">
                    <c:v>0.11348029687032812</c:v>
                  </c:pt>
                  <c:pt idx="3">
                    <c:v>0.18520259177452134</c:v>
                  </c:pt>
                </c:numCache>
              </c:numRef>
            </c:minus>
          </c:errBars>
          <c:cat>
            <c:strRef>
              <c:f>Sheet1!$A$64:$A$67</c:f>
              <c:strCache>
                <c:ptCount val="4"/>
                <c:pt idx="0">
                  <c:v>EPO-DNR-</c:v>
                </c:pt>
                <c:pt idx="1">
                  <c:v>EPO-DNR+</c:v>
                </c:pt>
                <c:pt idx="2">
                  <c:v>EPO+DNR-</c:v>
                </c:pt>
                <c:pt idx="3">
                  <c:v>EPO+DNR+</c:v>
                </c:pt>
              </c:strCache>
            </c:strRef>
          </c:cat>
          <c:val>
            <c:numRef>
              <c:f>Sheet1!$B$64:$B$67</c:f>
              <c:numCache>
                <c:formatCode>0.00</c:formatCode>
                <c:ptCount val="4"/>
                <c:pt idx="0">
                  <c:v>2.8933333333333331</c:v>
                </c:pt>
                <c:pt idx="1">
                  <c:v>38.666666666666664</c:v>
                </c:pt>
                <c:pt idx="2">
                  <c:v>0.64333333333333331</c:v>
                </c:pt>
                <c:pt idx="3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E3-4A48-874F-CAAA9CBF38F3}"/>
            </c:ext>
          </c:extLst>
        </c:ser>
        <c:ser>
          <c:idx val="1"/>
          <c:order val="1"/>
          <c:tx>
            <c:strRef>
              <c:f>Sheet1!$C$62</c:f>
              <c:strCache>
                <c:ptCount val="1"/>
                <c:pt idx="0">
                  <c:v>DA3/EPOR/p53DD #16</c:v>
                </c:pt>
              </c:strCache>
            </c:strRef>
          </c:tx>
          <c:spPr>
            <a:pattFill prst="dkUpDiag">
              <a:fgClr>
                <a:schemeClr val="tx1">
                  <a:lumMod val="95000"/>
                  <a:lumOff val="5000"/>
                </a:schemeClr>
              </a:fgClr>
              <a:bgClr>
                <a:schemeClr val="bg1"/>
              </a:bgClr>
            </a:pattFill>
          </c:spPr>
          <c:invertIfNegative val="0"/>
          <c:errBars>
            <c:errBarType val="both"/>
            <c:errValType val="cust"/>
            <c:noEndCap val="0"/>
            <c:plus>
              <c:numRef>
                <c:f>Sheet1!$C$79:$C$82</c:f>
                <c:numCache>
                  <c:formatCode>General</c:formatCode>
                  <c:ptCount val="4"/>
                  <c:pt idx="0">
                    <c:v>0.90879651799019956</c:v>
                  </c:pt>
                  <c:pt idx="1">
                    <c:v>6.1358210534532391</c:v>
                  </c:pt>
                  <c:pt idx="2">
                    <c:v>0.16502525059315418</c:v>
                  </c:pt>
                  <c:pt idx="3">
                    <c:v>0.43883684642219573</c:v>
                  </c:pt>
                </c:numCache>
              </c:numRef>
            </c:plus>
            <c:minus>
              <c:numRef>
                <c:f>Sheet1!$C$79:$C$82</c:f>
                <c:numCache>
                  <c:formatCode>General</c:formatCode>
                  <c:ptCount val="4"/>
                  <c:pt idx="0">
                    <c:v>0.90879651799019956</c:v>
                  </c:pt>
                  <c:pt idx="1">
                    <c:v>6.1358210534532391</c:v>
                  </c:pt>
                  <c:pt idx="2">
                    <c:v>0.16502525059315418</c:v>
                  </c:pt>
                  <c:pt idx="3">
                    <c:v>0.43883684642219573</c:v>
                  </c:pt>
                </c:numCache>
              </c:numRef>
            </c:minus>
          </c:errBars>
          <c:cat>
            <c:strRef>
              <c:f>Sheet1!$A$64:$A$67</c:f>
              <c:strCache>
                <c:ptCount val="4"/>
                <c:pt idx="0">
                  <c:v>EPO-DNR-</c:v>
                </c:pt>
                <c:pt idx="1">
                  <c:v>EPO-DNR+</c:v>
                </c:pt>
                <c:pt idx="2">
                  <c:v>EPO+DNR-</c:v>
                </c:pt>
                <c:pt idx="3">
                  <c:v>EPO+DNR+</c:v>
                </c:pt>
              </c:strCache>
            </c:strRef>
          </c:cat>
          <c:val>
            <c:numRef>
              <c:f>Sheet1!$C$64:$C$67</c:f>
              <c:numCache>
                <c:formatCode>0.00</c:formatCode>
                <c:ptCount val="4"/>
                <c:pt idx="0">
                  <c:v>1.5733333333333333</c:v>
                </c:pt>
                <c:pt idx="1">
                  <c:v>11.819999999999999</c:v>
                </c:pt>
                <c:pt idx="2">
                  <c:v>0.52</c:v>
                </c:pt>
                <c:pt idx="3">
                  <c:v>1.323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6E3-4A48-874F-CAAA9CBF38F3}"/>
            </c:ext>
          </c:extLst>
        </c:ser>
        <c:ser>
          <c:idx val="2"/>
          <c:order val="2"/>
          <c:tx>
            <c:strRef>
              <c:f>Sheet1!$D$62</c:f>
              <c:strCache>
                <c:ptCount val="1"/>
                <c:pt idx="0">
                  <c:v>DA3/EPOR/p53DD #18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D$79:$D$82</c:f>
                <c:numCache>
                  <c:formatCode>General</c:formatCode>
                  <c:ptCount val="4"/>
                  <c:pt idx="0">
                    <c:v>1.5164248891535788</c:v>
                  </c:pt>
                  <c:pt idx="1">
                    <c:v>2.3749128638986128</c:v>
                  </c:pt>
                  <c:pt idx="2">
                    <c:v>0.14518187826921677</c:v>
                  </c:pt>
                  <c:pt idx="3">
                    <c:v>0.30311347343491341</c:v>
                  </c:pt>
                </c:numCache>
              </c:numRef>
            </c:plus>
            <c:minus>
              <c:numRef>
                <c:f>Sheet1!$D$79:$D$82</c:f>
                <c:numCache>
                  <c:formatCode>General</c:formatCode>
                  <c:ptCount val="4"/>
                  <c:pt idx="0">
                    <c:v>1.5164248891535788</c:v>
                  </c:pt>
                  <c:pt idx="1">
                    <c:v>2.3749128638986128</c:v>
                  </c:pt>
                  <c:pt idx="2">
                    <c:v>0.14518187826921677</c:v>
                  </c:pt>
                  <c:pt idx="3">
                    <c:v>0.30311347343491341</c:v>
                  </c:pt>
                </c:numCache>
              </c:numRef>
            </c:minus>
          </c:errBars>
          <c:cat>
            <c:strRef>
              <c:f>Sheet1!$A$64:$A$67</c:f>
              <c:strCache>
                <c:ptCount val="4"/>
                <c:pt idx="0">
                  <c:v>EPO-DNR-</c:v>
                </c:pt>
                <c:pt idx="1">
                  <c:v>EPO-DNR+</c:v>
                </c:pt>
                <c:pt idx="2">
                  <c:v>EPO+DNR-</c:v>
                </c:pt>
                <c:pt idx="3">
                  <c:v>EPO+DNR+</c:v>
                </c:pt>
              </c:strCache>
            </c:strRef>
          </c:cat>
          <c:val>
            <c:numRef>
              <c:f>Sheet1!$D$64:$D$67</c:f>
              <c:numCache>
                <c:formatCode>0.00</c:formatCode>
                <c:ptCount val="4"/>
                <c:pt idx="0">
                  <c:v>2.8566666666666669</c:v>
                </c:pt>
                <c:pt idx="1">
                  <c:v>9.0666666666666682</c:v>
                </c:pt>
                <c:pt idx="2">
                  <c:v>1.0633333333333335</c:v>
                </c:pt>
                <c:pt idx="3">
                  <c:v>1.03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6E3-4A48-874F-CAAA9CBF38F3}"/>
            </c:ext>
          </c:extLst>
        </c:ser>
        <c:ser>
          <c:idx val="3"/>
          <c:order val="3"/>
          <c:tx>
            <c:strRef>
              <c:f>Sheet1!$E$62</c:f>
              <c:strCache>
                <c:ptCount val="1"/>
                <c:pt idx="0">
                  <c:v>DA3/EPOR/p53DD #19</c:v>
                </c:pt>
              </c:strCache>
            </c:strRef>
          </c:tx>
          <c:spPr>
            <a:pattFill prst="pct50">
              <a:fgClr>
                <a:schemeClr val="tx1">
                  <a:lumMod val="95000"/>
                  <a:lumOff val="5000"/>
                </a:schemeClr>
              </a:fgClr>
              <a:bgClr>
                <a:schemeClr val="bg1"/>
              </a:bgClr>
            </a:pattFill>
          </c:spPr>
          <c:invertIfNegative val="0"/>
          <c:errBars>
            <c:errBarType val="both"/>
            <c:errValType val="cust"/>
            <c:noEndCap val="0"/>
            <c:plus>
              <c:numRef>
                <c:f>Sheet1!$E$79:$E$82</c:f>
                <c:numCache>
                  <c:formatCode>General</c:formatCode>
                  <c:ptCount val="4"/>
                  <c:pt idx="0">
                    <c:v>1.4595927894831187</c:v>
                  </c:pt>
                  <c:pt idx="1">
                    <c:v>3.5882090859430762</c:v>
                  </c:pt>
                  <c:pt idx="2">
                    <c:v>0.39350278835663216</c:v>
                  </c:pt>
                  <c:pt idx="3">
                    <c:v>1.3798671433632057</c:v>
                  </c:pt>
                </c:numCache>
              </c:numRef>
            </c:plus>
            <c:minus>
              <c:numRef>
                <c:f>Sheet1!$E$79:$E$82</c:f>
                <c:numCache>
                  <c:formatCode>General</c:formatCode>
                  <c:ptCount val="4"/>
                  <c:pt idx="0">
                    <c:v>1.4595927894831187</c:v>
                  </c:pt>
                  <c:pt idx="1">
                    <c:v>3.5882090859430762</c:v>
                  </c:pt>
                  <c:pt idx="2">
                    <c:v>0.39350278835663216</c:v>
                  </c:pt>
                  <c:pt idx="3">
                    <c:v>1.3798671433632057</c:v>
                  </c:pt>
                </c:numCache>
              </c:numRef>
            </c:minus>
          </c:errBars>
          <c:cat>
            <c:strRef>
              <c:f>Sheet1!$A$64:$A$67</c:f>
              <c:strCache>
                <c:ptCount val="4"/>
                <c:pt idx="0">
                  <c:v>EPO-DNR-</c:v>
                </c:pt>
                <c:pt idx="1">
                  <c:v>EPO-DNR+</c:v>
                </c:pt>
                <c:pt idx="2">
                  <c:v>EPO+DNR-</c:v>
                </c:pt>
                <c:pt idx="3">
                  <c:v>EPO+DNR+</c:v>
                </c:pt>
              </c:strCache>
            </c:strRef>
          </c:cat>
          <c:val>
            <c:numRef>
              <c:f>Sheet1!$E$64:$E$67</c:f>
              <c:numCache>
                <c:formatCode>0.00</c:formatCode>
                <c:ptCount val="4"/>
                <c:pt idx="0">
                  <c:v>2.1233333333333331</c:v>
                </c:pt>
                <c:pt idx="1">
                  <c:v>10.806666666666667</c:v>
                </c:pt>
                <c:pt idx="2">
                  <c:v>0.8666666666666667</c:v>
                </c:pt>
                <c:pt idx="3">
                  <c:v>2.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6E3-4A48-874F-CAAA9CBF38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1341056"/>
        <c:axId val="121342592"/>
      </c:barChart>
      <c:catAx>
        <c:axId val="1213410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 b="1"/>
            </a:pPr>
            <a:endParaRPr lang="en-US"/>
          </a:p>
        </c:txPr>
        <c:crossAx val="121342592"/>
        <c:crosses val="autoZero"/>
        <c:auto val="1"/>
        <c:lblAlgn val="ctr"/>
        <c:lblOffset val="100"/>
        <c:noMultiLvlLbl val="0"/>
      </c:catAx>
      <c:valAx>
        <c:axId val="121342592"/>
        <c:scaling>
          <c:orientation val="minMax"/>
          <c:max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CA" sz="1200" dirty="0"/>
                  <a:t>Apoptosis</a:t>
                </a:r>
                <a:r>
                  <a:rPr lang="en-CA" sz="1200" baseline="0" dirty="0"/>
                  <a:t> (%)</a:t>
                </a:r>
                <a:endParaRPr lang="en-CA" sz="1200" dirty="0"/>
              </a:p>
            </c:rich>
          </c:tx>
          <c:layout>
            <c:manualLayout>
              <c:xMode val="edge"/>
              <c:yMode val="edge"/>
              <c:x val="0"/>
              <c:y val="0.45306980952234205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21341056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"/>
          <c:y val="0.10125891797771853"/>
          <c:w val="0.98884074065132899"/>
          <c:h val="7.8326572782787318E-2"/>
        </c:manualLayout>
      </c:layout>
      <c:overlay val="0"/>
      <c:txPr>
        <a:bodyPr/>
        <a:lstStyle/>
        <a:p>
          <a:pPr>
            <a:defRPr sz="105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[OCIM1 flow data Sep 2016.xlsx]Sheet1'!$G$4:$G$7</c:f>
                <c:numCache>
                  <c:formatCode>General</c:formatCode>
                  <c:ptCount val="4"/>
                  <c:pt idx="0">
                    <c:v>0.75078477460440274</c:v>
                  </c:pt>
                  <c:pt idx="1">
                    <c:v>0.98605273692637729</c:v>
                  </c:pt>
                  <c:pt idx="2">
                    <c:v>1.9409304755995573</c:v>
                  </c:pt>
                  <c:pt idx="3">
                    <c:v>2.54984966877134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OCIM1 flow data Sep 2016.xlsx]Sheet1'!$A$10:$A$13</c:f>
              <c:strCache>
                <c:ptCount val="4"/>
                <c:pt idx="0">
                  <c:v>EPO-</c:v>
                </c:pt>
                <c:pt idx="1">
                  <c:v>EPO+</c:v>
                </c:pt>
                <c:pt idx="2">
                  <c:v>DNR+</c:v>
                </c:pt>
                <c:pt idx="3">
                  <c:v>DNR+ EPO+</c:v>
                </c:pt>
              </c:strCache>
            </c:strRef>
          </c:cat>
          <c:val>
            <c:numRef>
              <c:f>'[OCIM1 flow data Sep 2016.xlsx]Sheet1'!$B$10:$B$13</c:f>
              <c:numCache>
                <c:formatCode>General</c:formatCode>
                <c:ptCount val="4"/>
                <c:pt idx="0">
                  <c:v>6.6466666666666656</c:v>
                </c:pt>
                <c:pt idx="1">
                  <c:v>5.17</c:v>
                </c:pt>
                <c:pt idx="2">
                  <c:v>19.856666666666666</c:v>
                </c:pt>
                <c:pt idx="3">
                  <c:v>21.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68-43EA-8E10-26CAC6CBEA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21162752"/>
        <c:axId val="121377536"/>
      </c:barChart>
      <c:catAx>
        <c:axId val="1211627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21377536"/>
        <c:crosses val="autoZero"/>
        <c:auto val="1"/>
        <c:lblAlgn val="ctr"/>
        <c:lblOffset val="100"/>
        <c:noMultiLvlLbl val="0"/>
      </c:catAx>
      <c:valAx>
        <c:axId val="1213775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 dirty="0" smtClean="0"/>
                  <a:t>Cell</a:t>
                </a:r>
                <a:r>
                  <a:rPr lang="en-US" sz="1400" baseline="0" dirty="0" smtClean="0"/>
                  <a:t> Death</a:t>
                </a:r>
                <a:r>
                  <a:rPr lang="en-US" sz="1400" dirty="0" smtClean="0"/>
                  <a:t> </a:t>
                </a:r>
                <a:r>
                  <a:rPr lang="en-US" sz="1400" dirty="0"/>
                  <a:t>(%)</a:t>
                </a:r>
              </a:p>
            </c:rich>
          </c:tx>
          <c:layout>
            <c:manualLayout>
              <c:xMode val="edge"/>
              <c:yMode val="edge"/>
              <c:x val="1.1111111111111112E-2"/>
              <c:y val="0.2549092300962379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211627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511187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093532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69401103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4D51B4D-AD22-4640-BD8F-F70401754614}" type="datetimeFigureOut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18-11-27</a:t>
            </a:fld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C0FB9C6-89BB-4C42-A90F-355E3EC38CA7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61681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4255913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966663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854823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545843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769313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931855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623742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870372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1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650196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D51B4D-AD22-4640-BD8F-F70401754614}" type="datetimeFigureOut">
              <a:rPr lang="en-CA" smtClean="0"/>
              <a:t>2018-11-27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FB9C6-89BB-4C42-A90F-355E3EC38CA7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4210783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5.emf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30058" y="1584884"/>
            <a:ext cx="2970950" cy="3888432"/>
            <a:chOff x="849868" y="1124744"/>
            <a:chExt cx="2970950" cy="388843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6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11" t="34102" r="53190" b="22747"/>
            <a:stretch/>
          </p:blipFill>
          <p:spPr>
            <a:xfrm>
              <a:off x="1351455" y="2467067"/>
              <a:ext cx="1774870" cy="20698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6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323" t="50000" r="52143" b="39859"/>
            <a:stretch/>
          </p:blipFill>
          <p:spPr>
            <a:xfrm>
              <a:off x="1351455" y="4717555"/>
              <a:ext cx="1774870" cy="2956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7" name="Straight Connector 6"/>
            <p:cNvCxnSpPr/>
            <p:nvPr/>
          </p:nvCxnSpPr>
          <p:spPr>
            <a:xfrm>
              <a:off x="1209531" y="2576004"/>
              <a:ext cx="144000" cy="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932909" y="2450644"/>
              <a:ext cx="357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63</a:t>
              </a:r>
              <a:endParaRPr lang="en-CA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930858" y="2668517"/>
              <a:ext cx="4082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48</a:t>
              </a:r>
              <a:endParaRPr lang="en-CA" sz="12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932909" y="3049797"/>
              <a:ext cx="357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35</a:t>
              </a:r>
              <a:endParaRPr lang="en-CA" sz="12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913362" y="3518220"/>
              <a:ext cx="4495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25</a:t>
              </a:r>
              <a:endParaRPr lang="en-CA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923741" y="3774310"/>
              <a:ext cx="4391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20</a:t>
              </a:r>
              <a:endParaRPr lang="en-CA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923742" y="4084697"/>
              <a:ext cx="4391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17</a:t>
              </a:r>
              <a:endParaRPr lang="en-CA" sz="12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849868" y="2152050"/>
              <a:ext cx="4409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 smtClean="0"/>
                <a:t>kDa</a:t>
              </a:r>
              <a:endParaRPr lang="en-CA" sz="12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1079166" y="1747398"/>
              <a:ext cx="9259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DA3-EPOR</a:t>
              </a:r>
              <a:endParaRPr lang="en-CA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1492783" y="1800974"/>
              <a:ext cx="818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PCDNA3</a:t>
              </a:r>
              <a:endParaRPr lang="en-CA" sz="1200" dirty="0"/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1864852" y="1885011"/>
              <a:ext cx="6507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16DD</a:t>
              </a:r>
              <a:endParaRPr lang="en-CA" sz="1200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2224893" y="1885013"/>
              <a:ext cx="65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18DD</a:t>
              </a:r>
              <a:endParaRPr lang="en-CA" sz="1200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2568276" y="1868356"/>
              <a:ext cx="6840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19DD</a:t>
              </a:r>
              <a:endParaRPr lang="en-CA" sz="12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351454" y="1124744"/>
              <a:ext cx="19853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b="1" dirty="0" smtClean="0"/>
                <a:t>EPO+DNR- 16h</a:t>
              </a:r>
              <a:endParaRPr lang="en-CA" sz="1200" b="1" dirty="0"/>
            </a:p>
          </p:txBody>
        </p:sp>
        <p:cxnSp>
          <p:nvCxnSpPr>
            <p:cNvPr id="21" name="Straight Connector 20"/>
            <p:cNvCxnSpPr/>
            <p:nvPr/>
          </p:nvCxnSpPr>
          <p:spPr>
            <a:xfrm>
              <a:off x="1351454" y="1412776"/>
              <a:ext cx="198537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3156525" y="4698077"/>
              <a:ext cx="6642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 smtClean="0"/>
                <a:t>β</a:t>
              </a:r>
              <a:r>
                <a:rPr lang="en-CA" sz="1200" b="1" dirty="0" smtClean="0"/>
                <a:t>-actin</a:t>
              </a:r>
              <a:endParaRPr lang="en-CA" sz="12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156525" y="3992184"/>
              <a:ext cx="639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 smtClean="0"/>
                <a:t>p53DD</a:t>
              </a:r>
              <a:endParaRPr lang="en-CA" sz="12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156526" y="2575937"/>
              <a:ext cx="639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 smtClean="0"/>
                <a:t>p53</a:t>
              </a:r>
              <a:endParaRPr lang="en-CA" sz="1200" b="1" dirty="0"/>
            </a:p>
          </p:txBody>
        </p:sp>
        <p:cxnSp>
          <p:nvCxnSpPr>
            <p:cNvPr id="28" name="Straight Connector 27"/>
            <p:cNvCxnSpPr/>
            <p:nvPr/>
          </p:nvCxnSpPr>
          <p:spPr>
            <a:xfrm>
              <a:off x="1209531" y="2793877"/>
              <a:ext cx="144000" cy="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1209531" y="3175156"/>
              <a:ext cx="144000" cy="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1209531" y="3665372"/>
              <a:ext cx="144000" cy="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1209531" y="3883246"/>
              <a:ext cx="144000" cy="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1209531" y="4210057"/>
              <a:ext cx="144000" cy="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"/>
          <p:cNvSpPr txBox="1"/>
          <p:nvPr/>
        </p:nvSpPr>
        <p:spPr>
          <a:xfrm>
            <a:off x="579782" y="1224844"/>
            <a:ext cx="7302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CA" sz="24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a</a:t>
            </a:r>
            <a:endParaRPr lang="en-CA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49" name="TextBox 4"/>
          <p:cNvSpPr txBox="1"/>
          <p:nvPr/>
        </p:nvSpPr>
        <p:spPr>
          <a:xfrm>
            <a:off x="3316086" y="1224844"/>
            <a:ext cx="7302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CA" sz="24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b</a:t>
            </a:r>
            <a:endParaRPr lang="en-CA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221088" y="0"/>
            <a:ext cx="2636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 smtClean="0"/>
              <a:t>Supplementary Figure 1</a:t>
            </a:r>
            <a:endParaRPr lang="en-CA" b="1" dirty="0"/>
          </a:p>
        </p:txBody>
      </p:sp>
      <p:grpSp>
        <p:nvGrpSpPr>
          <p:cNvPr id="51" name="Group 50"/>
          <p:cNvGrpSpPr/>
          <p:nvPr/>
        </p:nvGrpSpPr>
        <p:grpSpPr>
          <a:xfrm>
            <a:off x="3637111" y="1187624"/>
            <a:ext cx="2816225" cy="4542790"/>
            <a:chOff x="3015884" y="0"/>
            <a:chExt cx="2816764" cy="4974940"/>
          </a:xfrm>
        </p:grpSpPr>
        <p:grpSp>
          <p:nvGrpSpPr>
            <p:cNvPr id="52" name="Group 51"/>
            <p:cNvGrpSpPr/>
            <p:nvPr/>
          </p:nvGrpSpPr>
          <p:grpSpPr>
            <a:xfrm>
              <a:off x="3015884" y="0"/>
              <a:ext cx="2816764" cy="4974940"/>
              <a:chOff x="3015884" y="0"/>
              <a:chExt cx="8352928" cy="6243791"/>
            </a:xfrm>
          </p:grpSpPr>
          <p:graphicFrame>
            <p:nvGraphicFramePr>
              <p:cNvPr id="61" name="Chart 6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61090062"/>
                  </p:ext>
                </p:extLst>
              </p:nvPr>
            </p:nvGraphicFramePr>
            <p:xfrm>
              <a:off x="3015884" y="0"/>
              <a:ext cx="8352928" cy="624379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cxnSp>
            <p:nvCxnSpPr>
              <p:cNvPr id="62" name="Straight Connector 61"/>
              <p:cNvCxnSpPr/>
              <p:nvPr/>
            </p:nvCxnSpPr>
            <p:spPr>
              <a:xfrm>
                <a:off x="6884576" y="2222896"/>
                <a:ext cx="85414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/>
              <p:cNvCxnSpPr/>
              <p:nvPr/>
            </p:nvCxnSpPr>
            <p:spPr>
              <a:xfrm flipV="1">
                <a:off x="6884576" y="2221154"/>
                <a:ext cx="0" cy="72008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/>
              <p:cNvCxnSpPr/>
              <p:nvPr/>
            </p:nvCxnSpPr>
            <p:spPr>
              <a:xfrm flipV="1">
                <a:off x="7738717" y="2211100"/>
                <a:ext cx="0" cy="72008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TextBox 44"/>
              <p:cNvSpPr txBox="1"/>
              <p:nvPr/>
            </p:nvSpPr>
            <p:spPr>
              <a:xfrm>
                <a:off x="6333300" y="1941681"/>
                <a:ext cx="2257777" cy="3176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CA" sz="900" kern="1200" dirty="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p&lt; 0.0001</a:t>
                </a:r>
                <a:endParaRPr lang="en-CA" sz="1200" dirty="0">
                  <a:effectLst/>
                  <a:latin typeface="Times New Roman"/>
                  <a:ea typeface="Times New Roman"/>
                </a:endParaRPr>
              </a:p>
            </p:txBody>
          </p:sp>
        </p:grpSp>
        <p:cxnSp>
          <p:nvCxnSpPr>
            <p:cNvPr id="53" name="Straight Connector 52"/>
            <p:cNvCxnSpPr/>
            <p:nvPr/>
          </p:nvCxnSpPr>
          <p:spPr>
            <a:xfrm>
              <a:off x="4320480" y="1491143"/>
              <a:ext cx="14401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 flipV="1">
              <a:off x="4320480" y="1489754"/>
              <a:ext cx="0" cy="5737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flipV="1">
              <a:off x="4464496" y="1489754"/>
              <a:ext cx="0" cy="5737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>
              <a:off x="4320480" y="1211122"/>
              <a:ext cx="7200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 flipV="1">
              <a:off x="4320480" y="1209733"/>
              <a:ext cx="0" cy="5737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 flipV="1">
              <a:off x="4392488" y="1209733"/>
              <a:ext cx="0" cy="5737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63"/>
            <p:cNvSpPr txBox="1"/>
            <p:nvPr/>
          </p:nvSpPr>
          <p:spPr>
            <a:xfrm>
              <a:off x="4134579" y="1252273"/>
              <a:ext cx="761365" cy="2531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CA" sz="900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p&lt; 0.0001</a:t>
              </a:r>
              <a:endParaRPr lang="en-CA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60" name="TextBox 64"/>
            <p:cNvSpPr txBox="1"/>
            <p:nvPr/>
          </p:nvSpPr>
          <p:spPr>
            <a:xfrm>
              <a:off x="4134579" y="971045"/>
              <a:ext cx="761365" cy="2531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CA" sz="900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p&lt; 0.0001</a:t>
              </a:r>
              <a:endParaRPr lang="en-CA" sz="1200" dirty="0">
                <a:effectLst/>
                <a:latin typeface="Times New Roman"/>
                <a:ea typeface="Times New Roman"/>
              </a:endParaRPr>
            </a:p>
          </p:txBody>
        </p:sp>
      </p:grpSp>
      <p:cxnSp>
        <p:nvCxnSpPr>
          <p:cNvPr id="3" name="Straight Connector 2"/>
          <p:cNvCxnSpPr/>
          <p:nvPr/>
        </p:nvCxnSpPr>
        <p:spPr>
          <a:xfrm>
            <a:off x="835445" y="5268634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547237" y="5134671"/>
            <a:ext cx="439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48</a:t>
            </a:r>
            <a:endParaRPr lang="en-CA" sz="1200" dirty="0"/>
          </a:p>
        </p:txBody>
      </p:sp>
    </p:spTree>
    <p:extLst>
      <p:ext uri="{BB962C8B-B14F-4D97-AF65-F5344CB8AC3E}">
        <p14:creationId xmlns:p14="http://schemas.microsoft.com/office/powerpoint/2010/main" val="537818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8402723"/>
              </p:ext>
            </p:extLst>
          </p:nvPr>
        </p:nvGraphicFramePr>
        <p:xfrm>
          <a:off x="661928" y="4205315"/>
          <a:ext cx="5472307" cy="27429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4"/>
          <p:cNvSpPr txBox="1"/>
          <p:nvPr/>
        </p:nvSpPr>
        <p:spPr>
          <a:xfrm>
            <a:off x="579755" y="3845308"/>
            <a:ext cx="7302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2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Times New Roman"/>
                <a:cs typeface="+mn-cs"/>
              </a:rPr>
              <a:t>c</a:t>
            </a:r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ea typeface="Times New Roman"/>
              <a:cs typeface="+mn-cs"/>
            </a:endParaRP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247"/>
          <a:stretch/>
        </p:blipFill>
        <p:spPr>
          <a:xfrm>
            <a:off x="944860" y="2152948"/>
            <a:ext cx="1370653" cy="5613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b="7267"/>
          <a:stretch/>
        </p:blipFill>
        <p:spPr>
          <a:xfrm>
            <a:off x="944860" y="2800270"/>
            <a:ext cx="1370653" cy="83241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TextBox 22"/>
          <p:cNvSpPr txBox="1"/>
          <p:nvPr/>
        </p:nvSpPr>
        <p:spPr>
          <a:xfrm>
            <a:off x="872856" y="1583393"/>
            <a:ext cx="1512085" cy="2769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Times New Roman"/>
                <a:cs typeface="Times New Roman"/>
              </a:rPr>
              <a:t>EPO treatment (min)</a:t>
            </a:r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ea typeface="Times New Roman"/>
              <a:cs typeface="+mn-cs"/>
            </a:endParaRPr>
          </a:p>
        </p:txBody>
      </p:sp>
      <p:sp>
        <p:nvSpPr>
          <p:cNvPr id="22" name="TextBox 23"/>
          <p:cNvSpPr txBox="1"/>
          <p:nvPr/>
        </p:nvSpPr>
        <p:spPr>
          <a:xfrm>
            <a:off x="944860" y="1861043"/>
            <a:ext cx="1370653" cy="2769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Times New Roman"/>
                <a:cs typeface="Times New Roman"/>
              </a:rPr>
              <a:t> 0       5      10     20</a:t>
            </a:r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ea typeface="Times New Roman"/>
              <a:cs typeface="+mn-cs"/>
            </a:endParaRPr>
          </a:p>
        </p:txBody>
      </p:sp>
      <p:sp>
        <p:nvSpPr>
          <p:cNvPr id="23" name="TextBox 24"/>
          <p:cNvSpPr txBox="1"/>
          <p:nvPr/>
        </p:nvSpPr>
        <p:spPr>
          <a:xfrm>
            <a:off x="2348880" y="2270066"/>
            <a:ext cx="648036" cy="2769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Times New Roman"/>
                <a:cs typeface="Times New Roman"/>
              </a:rPr>
              <a:t>pJAK2</a:t>
            </a:r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ea typeface="Times New Roman"/>
              <a:cs typeface="+mn-cs"/>
            </a:endParaRPr>
          </a:p>
        </p:txBody>
      </p:sp>
      <p:sp>
        <p:nvSpPr>
          <p:cNvPr id="24" name="TextBox 25"/>
          <p:cNvSpPr txBox="1"/>
          <p:nvPr/>
        </p:nvSpPr>
        <p:spPr>
          <a:xfrm>
            <a:off x="2348880" y="3088302"/>
            <a:ext cx="648334" cy="2769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Times New Roman"/>
                <a:cs typeface="Times New Roman"/>
              </a:rPr>
              <a:t>JAK2</a:t>
            </a:r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ea typeface="Times New Roman"/>
              <a:cs typeface="+mn-cs"/>
            </a:endParaRPr>
          </a:p>
        </p:txBody>
      </p:sp>
      <p:sp>
        <p:nvSpPr>
          <p:cNvPr id="25" name="TextBox 4"/>
          <p:cNvSpPr txBox="1"/>
          <p:nvPr/>
        </p:nvSpPr>
        <p:spPr>
          <a:xfrm>
            <a:off x="502666" y="1176296"/>
            <a:ext cx="7302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2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Times New Roman"/>
                <a:cs typeface="+mn-cs"/>
              </a:rPr>
              <a:t>a</a:t>
            </a:r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ea typeface="Times New Roman"/>
              <a:cs typeface="+mn-cs"/>
            </a:endParaRPr>
          </a:p>
        </p:txBody>
      </p:sp>
      <p:grpSp>
        <p:nvGrpSpPr>
          <p:cNvPr id="31" name="Group 30"/>
          <p:cNvGrpSpPr/>
          <p:nvPr/>
        </p:nvGrpSpPr>
        <p:grpSpPr>
          <a:xfrm>
            <a:off x="404664" y="2906290"/>
            <a:ext cx="432040" cy="542160"/>
            <a:chOff x="404664" y="2906290"/>
            <a:chExt cx="432040" cy="542160"/>
          </a:xfrm>
        </p:grpSpPr>
        <p:cxnSp>
          <p:nvCxnSpPr>
            <p:cNvPr id="26" name="Straight Connector 25"/>
            <p:cNvCxnSpPr/>
            <p:nvPr/>
          </p:nvCxnSpPr>
          <p:spPr>
            <a:xfrm>
              <a:off x="764704" y="3035242"/>
              <a:ext cx="72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764704" y="3321463"/>
              <a:ext cx="72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404664" y="2906290"/>
              <a:ext cx="41675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135</a:t>
              </a:r>
              <a:endParaRPr kumimoji="0" lang="en-CA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04664" y="3194534"/>
              <a:ext cx="41675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100</a:t>
              </a:r>
              <a:endParaRPr kumimoji="0" lang="en-CA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cxnSp>
        <p:nvCxnSpPr>
          <p:cNvPr id="33" name="Straight Connector 32"/>
          <p:cNvCxnSpPr/>
          <p:nvPr/>
        </p:nvCxnSpPr>
        <p:spPr>
          <a:xfrm>
            <a:off x="764704" y="2324688"/>
            <a:ext cx="7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764704" y="2610909"/>
            <a:ext cx="7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04664" y="2195736"/>
            <a:ext cx="4167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135</a:t>
            </a:r>
            <a:endParaRPr kumimoji="0" lang="en-CA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04664" y="2479217"/>
            <a:ext cx="4167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100</a:t>
            </a:r>
            <a:endParaRPr kumimoji="0" lang="en-CA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26942" y="1974589"/>
            <a:ext cx="411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kDa</a:t>
            </a:r>
            <a:endParaRPr kumimoji="0" lang="en-CA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3063217" y="1176799"/>
            <a:ext cx="3606143" cy="2360702"/>
            <a:chOff x="2873824" y="1176799"/>
            <a:chExt cx="3606143" cy="2360702"/>
          </a:xfrm>
        </p:grpSpPr>
        <p:sp>
          <p:nvSpPr>
            <p:cNvPr id="9" name="TextBox 4"/>
            <p:cNvSpPr txBox="1"/>
            <p:nvPr/>
          </p:nvSpPr>
          <p:spPr>
            <a:xfrm>
              <a:off x="3198139" y="1176799"/>
              <a:ext cx="73021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24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+mn-cs"/>
                </a:rPr>
                <a:t>b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</p:txBody>
        </p:sp>
        <p:sp>
          <p:nvSpPr>
            <p:cNvPr id="11" name="TextBox 28"/>
            <p:cNvSpPr txBox="1"/>
            <p:nvPr/>
          </p:nvSpPr>
          <p:spPr>
            <a:xfrm>
              <a:off x="5869590" y="2061146"/>
              <a:ext cx="610377" cy="523172"/>
            </a:xfrm>
            <a:prstGeom prst="rect">
              <a:avLst/>
            </a:prstGeom>
            <a:noFill/>
          </p:spPr>
          <p:txBody>
            <a:bodyPr wrap="square" spcCol="72000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538480" algn="l"/>
                  <a:tab pos="805180" algn="l"/>
                  <a:tab pos="1076325" algn="l"/>
                  <a:tab pos="1343025" algn="l"/>
                  <a:tab pos="1614805" algn="l"/>
                  <a:tab pos="2237105" algn="l"/>
                  <a:tab pos="2602230" algn="l"/>
                  <a:tab pos="2955925" algn="l"/>
                  <a:tab pos="3319780" algn="l"/>
                </a:tabLst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+mn-cs"/>
                </a:rPr>
                <a:t>EPO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538480" algn="l"/>
                  <a:tab pos="805180" algn="l"/>
                  <a:tab pos="1076325" algn="l"/>
                  <a:tab pos="1343025" algn="l"/>
                  <a:tab pos="1614805" algn="l"/>
                  <a:tab pos="2237105" algn="l"/>
                  <a:tab pos="2602230" algn="l"/>
                  <a:tab pos="2955925" algn="l"/>
                  <a:tab pos="3319780" algn="l"/>
                </a:tabLst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+mn-cs"/>
                </a:rPr>
                <a:t>DNR 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</p:txBody>
        </p:sp>
        <p:sp>
          <p:nvSpPr>
            <p:cNvPr id="12" name="TextBox 29"/>
            <p:cNvSpPr txBox="1"/>
            <p:nvPr/>
          </p:nvSpPr>
          <p:spPr>
            <a:xfrm>
              <a:off x="4072357" y="2016942"/>
              <a:ext cx="324847" cy="584721"/>
            </a:xfrm>
            <a:prstGeom prst="rect">
              <a:avLst/>
            </a:prstGeom>
            <a:noFill/>
          </p:spPr>
          <p:txBody>
            <a:bodyPr wrap="square" spcCol="72000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538480" algn="l"/>
                  <a:tab pos="805180" algn="l"/>
                  <a:tab pos="1076325" algn="l"/>
                  <a:tab pos="1343025" algn="l"/>
                  <a:tab pos="1614805" algn="l"/>
                  <a:tab pos="2237105" algn="l"/>
                  <a:tab pos="2602230" algn="l"/>
                  <a:tab pos="2955925" algn="l"/>
                  <a:tab pos="3319780" algn="l"/>
                </a:tabLst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+mn-cs"/>
                </a:rPr>
                <a:t>+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538480" algn="l"/>
                  <a:tab pos="805180" algn="l"/>
                  <a:tab pos="1076325" algn="l"/>
                  <a:tab pos="1343025" algn="l"/>
                  <a:tab pos="1614805" algn="l"/>
                  <a:tab pos="2237105" algn="l"/>
                  <a:tab pos="2602230" algn="l"/>
                  <a:tab pos="2955925" algn="l"/>
                  <a:tab pos="3319780" algn="l"/>
                </a:tabLst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+mn-cs"/>
                </a:rPr>
                <a:t>-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</p:txBody>
        </p:sp>
        <p:sp>
          <p:nvSpPr>
            <p:cNvPr id="13" name="TextBox 30"/>
            <p:cNvSpPr txBox="1"/>
            <p:nvPr/>
          </p:nvSpPr>
          <p:spPr>
            <a:xfrm>
              <a:off x="3526296" y="2016942"/>
              <a:ext cx="396229" cy="584721"/>
            </a:xfrm>
            <a:prstGeom prst="rect">
              <a:avLst/>
            </a:prstGeom>
            <a:noFill/>
          </p:spPr>
          <p:txBody>
            <a:bodyPr wrap="square" spcCol="72000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538480" algn="l"/>
                  <a:tab pos="805180" algn="l"/>
                  <a:tab pos="1076325" algn="l"/>
                  <a:tab pos="1343025" algn="l"/>
                  <a:tab pos="1614805" algn="l"/>
                  <a:tab pos="2237105" algn="l"/>
                  <a:tab pos="2602230" algn="l"/>
                  <a:tab pos="2955925" algn="l"/>
                  <a:tab pos="3319780" algn="l"/>
                </a:tabLst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+mn-cs"/>
                </a:rPr>
                <a:t>-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538480" algn="l"/>
                  <a:tab pos="805180" algn="l"/>
                  <a:tab pos="1076325" algn="l"/>
                  <a:tab pos="1343025" algn="l"/>
                  <a:tab pos="1614805" algn="l"/>
                  <a:tab pos="2237105" algn="l"/>
                  <a:tab pos="2602230" algn="l"/>
                  <a:tab pos="2955925" algn="l"/>
                  <a:tab pos="3319780" algn="l"/>
                </a:tabLst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+mn-cs"/>
                </a:rPr>
                <a:t>-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</p:txBody>
        </p:sp>
        <p:sp>
          <p:nvSpPr>
            <p:cNvPr id="14" name="TextBox 43"/>
            <p:cNvSpPr txBox="1"/>
            <p:nvPr/>
          </p:nvSpPr>
          <p:spPr>
            <a:xfrm>
              <a:off x="4679867" y="2008307"/>
              <a:ext cx="324847" cy="584721"/>
            </a:xfrm>
            <a:prstGeom prst="rect">
              <a:avLst/>
            </a:prstGeom>
            <a:noFill/>
          </p:spPr>
          <p:txBody>
            <a:bodyPr wrap="square" spcCol="72000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538480" algn="l"/>
                  <a:tab pos="805180" algn="l"/>
                  <a:tab pos="1076325" algn="l"/>
                  <a:tab pos="1343025" algn="l"/>
                  <a:tab pos="1614805" algn="l"/>
                  <a:tab pos="2237105" algn="l"/>
                  <a:tab pos="2602230" algn="l"/>
                  <a:tab pos="2955925" algn="l"/>
                  <a:tab pos="3319780" algn="l"/>
                </a:tabLst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+mn-cs"/>
                </a:rPr>
                <a:t>-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538480" algn="l"/>
                  <a:tab pos="805180" algn="l"/>
                  <a:tab pos="1076325" algn="l"/>
                  <a:tab pos="1343025" algn="l"/>
                  <a:tab pos="1614805" algn="l"/>
                  <a:tab pos="2237105" algn="l"/>
                  <a:tab pos="2602230" algn="l"/>
                  <a:tab pos="2955925" algn="l"/>
                  <a:tab pos="3319780" algn="l"/>
                </a:tabLst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+mn-cs"/>
                </a:rPr>
                <a:t>+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</p:txBody>
        </p:sp>
        <p:sp>
          <p:nvSpPr>
            <p:cNvPr id="15" name="TextBox 44"/>
            <p:cNvSpPr txBox="1"/>
            <p:nvPr/>
          </p:nvSpPr>
          <p:spPr>
            <a:xfrm>
              <a:off x="5259595" y="2008307"/>
              <a:ext cx="324847" cy="584721"/>
            </a:xfrm>
            <a:prstGeom prst="rect">
              <a:avLst/>
            </a:prstGeom>
            <a:noFill/>
          </p:spPr>
          <p:txBody>
            <a:bodyPr wrap="square" spcCol="72000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538480" algn="l"/>
                  <a:tab pos="805180" algn="l"/>
                  <a:tab pos="1076325" algn="l"/>
                  <a:tab pos="1343025" algn="l"/>
                  <a:tab pos="1614805" algn="l"/>
                  <a:tab pos="2237105" algn="l"/>
                  <a:tab pos="2602230" algn="l"/>
                  <a:tab pos="2955925" algn="l"/>
                  <a:tab pos="3319780" algn="l"/>
                </a:tabLst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+mn-cs"/>
                </a:rPr>
                <a:t>+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538480" algn="l"/>
                  <a:tab pos="805180" algn="l"/>
                  <a:tab pos="1076325" algn="l"/>
                  <a:tab pos="1343025" algn="l"/>
                  <a:tab pos="1614805" algn="l"/>
                  <a:tab pos="2237105" algn="l"/>
                  <a:tab pos="2602230" algn="l"/>
                  <a:tab pos="2955925" algn="l"/>
                  <a:tab pos="3319780" algn="l"/>
                </a:tabLst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+mn-cs"/>
                </a:rPr>
                <a:t>+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</p:txBody>
        </p:sp>
        <p:sp>
          <p:nvSpPr>
            <p:cNvPr id="16" name="TextBox 10"/>
            <p:cNvSpPr txBox="1"/>
            <p:nvPr/>
          </p:nvSpPr>
          <p:spPr>
            <a:xfrm>
              <a:off x="4072483" y="1712026"/>
              <a:ext cx="824820" cy="3396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16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Times New Roman"/>
                </a:rPr>
                <a:t>OCI-M1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3383879" y="2027359"/>
              <a:ext cx="230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9"/>
            <p:cNvSpPr txBox="1"/>
            <p:nvPr/>
          </p:nvSpPr>
          <p:spPr>
            <a:xfrm>
              <a:off x="5912775" y="2739193"/>
              <a:ext cx="419712" cy="2774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Times New Roman"/>
                </a:rPr>
                <a:t>p53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</p:txBody>
        </p:sp>
        <p:sp>
          <p:nvSpPr>
            <p:cNvPr id="7" name="TextBox 28"/>
            <p:cNvSpPr txBox="1"/>
            <p:nvPr/>
          </p:nvSpPr>
          <p:spPr>
            <a:xfrm>
              <a:off x="5875909" y="3054467"/>
              <a:ext cx="602615" cy="2774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Times New Roman"/>
                  <a:sym typeface="Symbol"/>
                </a:rPr>
                <a:t></a:t>
              </a:r>
              <a:r>
                <a: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Times New Roman"/>
                </a:rPr>
                <a:t>-</a:t>
              </a:r>
              <a:r>
                <a:rPr kumimoji="0" lang="en-CA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Times New Roman"/>
                  <a:cs typeface="Times New Roman"/>
                </a:rPr>
                <a:t>actin</a:t>
              </a:r>
              <a:endPara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Times New Roman"/>
                <a:cs typeface="+mn-cs"/>
              </a:endParaRPr>
            </a:p>
          </p:txBody>
        </p:sp>
        <p:grpSp>
          <p:nvGrpSpPr>
            <p:cNvPr id="37" name="Group 36"/>
            <p:cNvGrpSpPr/>
            <p:nvPr/>
          </p:nvGrpSpPr>
          <p:grpSpPr>
            <a:xfrm>
              <a:off x="2878283" y="3179349"/>
              <a:ext cx="416754" cy="253916"/>
              <a:chOff x="443125" y="3199297"/>
              <a:chExt cx="416754" cy="253916"/>
            </a:xfrm>
          </p:grpSpPr>
          <p:cxnSp>
            <p:nvCxnSpPr>
              <p:cNvPr id="39" name="Straight Connector 38"/>
              <p:cNvCxnSpPr/>
              <p:nvPr/>
            </p:nvCxnSpPr>
            <p:spPr>
              <a:xfrm>
                <a:off x="764704" y="3321463"/>
                <a:ext cx="7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1" name="TextBox 40"/>
              <p:cNvSpPr txBox="1"/>
              <p:nvPr/>
            </p:nvSpPr>
            <p:spPr>
              <a:xfrm>
                <a:off x="443125" y="3199297"/>
                <a:ext cx="41675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CA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 </a:t>
                </a:r>
                <a:r>
                  <a:rPr kumimoji="0" lang="en-CA" sz="10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 48</a:t>
                </a:r>
                <a:endParaRPr kumimoji="0" lang="en-CA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</p:grpSp>
        <p:sp>
          <p:nvSpPr>
            <p:cNvPr id="40" name="TextBox 39"/>
            <p:cNvSpPr txBox="1"/>
            <p:nvPr/>
          </p:nvSpPr>
          <p:spPr>
            <a:xfrm>
              <a:off x="2873824" y="2339752"/>
              <a:ext cx="4111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kDa</a:t>
              </a:r>
              <a:endParaRPr kumimoji="0" lang="en-CA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5"/>
            <a:srcRect l="12890"/>
            <a:stretch/>
          </p:blipFill>
          <p:spPr>
            <a:xfrm>
              <a:off x="3337336" y="2566339"/>
              <a:ext cx="2556000" cy="971162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grpSp>
          <p:nvGrpSpPr>
            <p:cNvPr id="43" name="Group 42"/>
            <p:cNvGrpSpPr/>
            <p:nvPr/>
          </p:nvGrpSpPr>
          <p:grpSpPr>
            <a:xfrm>
              <a:off x="2876382" y="2616061"/>
              <a:ext cx="416754" cy="253916"/>
              <a:chOff x="443125" y="3199297"/>
              <a:chExt cx="416754" cy="253916"/>
            </a:xfrm>
          </p:grpSpPr>
          <p:cxnSp>
            <p:nvCxnSpPr>
              <p:cNvPr id="44" name="Straight Connector 43"/>
              <p:cNvCxnSpPr/>
              <p:nvPr/>
            </p:nvCxnSpPr>
            <p:spPr>
              <a:xfrm>
                <a:off x="764704" y="3321463"/>
                <a:ext cx="7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5" name="TextBox 44"/>
              <p:cNvSpPr txBox="1"/>
              <p:nvPr/>
            </p:nvSpPr>
            <p:spPr>
              <a:xfrm>
                <a:off x="443125" y="3199297"/>
                <a:ext cx="41675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CA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 </a:t>
                </a:r>
                <a:r>
                  <a:rPr kumimoji="0" lang="en-CA" sz="10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 63</a:t>
                </a:r>
                <a:endParaRPr kumimoji="0" lang="en-CA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</p:grpSp>
      </p:grpSp>
      <p:cxnSp>
        <p:nvCxnSpPr>
          <p:cNvPr id="42" name="Straight Connector 41"/>
          <p:cNvCxnSpPr/>
          <p:nvPr/>
        </p:nvCxnSpPr>
        <p:spPr>
          <a:xfrm>
            <a:off x="878574" y="1835696"/>
            <a:ext cx="14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4221088" y="0"/>
            <a:ext cx="2636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 smtClean="0"/>
              <a:t>Supplementary Figure 2</a:t>
            </a:r>
            <a:endParaRPr lang="en-CA" b="1" dirty="0"/>
          </a:p>
        </p:txBody>
      </p:sp>
    </p:spTree>
    <p:extLst>
      <p:ext uri="{BB962C8B-B14F-4D97-AF65-F5344CB8AC3E}">
        <p14:creationId xmlns:p14="http://schemas.microsoft.com/office/powerpoint/2010/main" val="1870988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903</TotalTime>
  <Words>81</Words>
  <Application>Microsoft Office PowerPoint</Application>
  <PresentationFormat>Letter Paper (8.5x11 in)</PresentationFormat>
  <Paragraphs>5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Symbol</vt:lpstr>
      <vt:lpstr>Times New Roman</vt:lpstr>
      <vt:lpstr>Office Theme</vt:lpstr>
      <vt:lpstr>1_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uc-Nghi</dc:creator>
  <cp:lastModifiedBy>Samuel Benchimol</cp:lastModifiedBy>
  <cp:revision>54</cp:revision>
  <cp:lastPrinted>2018-08-28T17:39:05Z</cp:lastPrinted>
  <dcterms:created xsi:type="dcterms:W3CDTF">2018-08-19T16:37:34Z</dcterms:created>
  <dcterms:modified xsi:type="dcterms:W3CDTF">2018-11-27T23:27:57Z</dcterms:modified>
</cp:coreProperties>
</file>